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sldIdLst>
    <p:sldId id="270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08"/>
    <p:restoredTop sz="96901" autoAdjust="0"/>
  </p:normalViewPr>
  <p:slideViewPr>
    <p:cSldViewPr>
      <p:cViewPr>
        <p:scale>
          <a:sx n="90" d="100"/>
          <a:sy n="90" d="100"/>
        </p:scale>
        <p:origin x="-1050" y="-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85720" y="1928802"/>
            <a:ext cx="85011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able S1. Statistics of raw and mapped reads from RNA-seq analysis of PBMCs from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hypertensives  (Hyp) and normotensive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(Con)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ighter pilot 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105692" y="2571744"/>
            <a:ext cx="88200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>
            <a:off x="116468" y="2927346"/>
            <a:ext cx="88200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116468" y="4607176"/>
            <a:ext cx="88200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131656" y="2572660"/>
            <a:ext cx="714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4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329620" y="2564004"/>
            <a:ext cx="714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5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29770" y="2571068"/>
            <a:ext cx="714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6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728986" y="2570642"/>
            <a:ext cx="714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Hyp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928202" y="2571068"/>
            <a:ext cx="714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Hyp2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127418" y="2571744"/>
            <a:ext cx="714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Hyp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654" y="2930036"/>
            <a:ext cx="1071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Total reads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862" y="3252008"/>
            <a:ext cx="16430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Unmapped reads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964" y="3568537"/>
            <a:ext cx="16430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Mapped reads (Rate)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760" y="3880665"/>
            <a:ext cx="18573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Unique mapped (Rate)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894" y="4197234"/>
            <a:ext cx="18573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Repeat mapped 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028812" y="2928934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501996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027710" y="3259709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681703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027710" y="358942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4338258 (0.96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027710" y="391034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3808508 (0.92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027710" y="4241155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2975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252050" y="2928934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317406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250948" y="3259709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648559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50948" y="358942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525509 (0.95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250948" y="391034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055535 (0.92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250948" y="4241155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469974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431328" y="2928934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3337762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430226" y="3259709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6569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430226" y="358942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772072 (0.96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430226" y="391034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319880 (0.92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430226" y="4241155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452192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600712" y="2928934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848613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599610" y="3259709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9080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599610" y="358942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257812 (0.95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599610" y="391034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1821397 (0.92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599610" y="4241155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436415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806366" y="2928934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3549300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805264" y="3259709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8875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805264" y="358942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960542 (0.96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805264" y="391034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456996 (0.92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805264" y="4241155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03546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958166" y="2928934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732717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957064" y="3259709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506122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957064" y="358942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2226595 (0.96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957064" y="3910341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11839683 (0.93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957064" y="4241155"/>
            <a:ext cx="1205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386912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3</TotalTime>
  <Words>114</Words>
  <Application>Microsoft Macintosh PowerPoint</Application>
  <PresentationFormat>全屏显示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c</dc:creator>
  <cp:lastModifiedBy>pc</cp:lastModifiedBy>
  <cp:revision>95</cp:revision>
  <dcterms:created xsi:type="dcterms:W3CDTF">2017-06-27T09:06:27Z</dcterms:created>
  <dcterms:modified xsi:type="dcterms:W3CDTF">2017-08-31T02:28:33Z</dcterms:modified>
</cp:coreProperties>
</file>